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73152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0" y="685440"/>
            <a:ext cx="6858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50AB4B03-8B8C-44B2-B560-9A69B321F52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0" y="685800"/>
            <a:ext cx="685800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0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F1EA5417-5C4C-49AE-9592-07177C14083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A2BD1-A6F3-43B0-98CB-0595151A7E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0D2B0-F244-4679-9C3B-726ED93ED1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26E9E-CC71-4A57-9994-8E7CF98024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9164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817880" y="85356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50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9164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817880" y="2114280"/>
            <a:ext cx="212004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6E4D8C-907B-440A-A0A7-13D95B1C54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50"/>
              </a:spcBef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E9AA3-7F28-4FC9-AACC-C144922B95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7DC09B-0F7A-4603-84F8-C3159123C6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AB2126-627D-4027-B53C-D30C488729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30FC8-A8C3-48E8-8276-3EE2289F91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5040" y="145800"/>
            <a:ext cx="658512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50"/>
              </a:spcBef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97600-2936-44AB-900E-EFDAA68763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F71D9-5A1A-4DE1-8EDE-4E480A42D6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739320" y="211428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98507-CE4A-4183-9663-4760F5DDFB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504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739320" y="853560"/>
            <a:ext cx="321336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5040" y="2114280"/>
            <a:ext cx="6585120" cy="11509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/>
          </a:bodyPr>
          <a:p>
            <a:pPr indent="0">
              <a:spcBef>
                <a:spcPts val="550"/>
              </a:spcBef>
              <a:buNone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00B6D-8932-48F7-B01B-D5F951FEA4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5040" y="145800"/>
            <a:ext cx="6585120" cy="6094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 algn="ctr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31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5040" y="853560"/>
            <a:ext cx="6585120" cy="241308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t">
            <a:normAutofit fontScale="85000"/>
          </a:bodyPr>
          <a:p>
            <a:pPr marL="203760" indent="-20376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1" marL="442440" indent="-16956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2" marL="681120" indent="-136080"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3" marL="954000" indent="-136440">
              <a:spcBef>
                <a:spcPts val="550"/>
              </a:spcBef>
              <a:buClr>
                <a:srgbClr val="000000"/>
              </a:buClr>
              <a:buFont typeface="Arial"/>
              <a:buChar char="–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4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5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  <a:p>
            <a:pPr lvl="6" marL="1226160" indent="-136080">
              <a:spcBef>
                <a:spcPts val="550"/>
              </a:spcBef>
              <a:buClr>
                <a:srgbClr val="000000"/>
              </a:buClr>
              <a:buFont typeface="Arial"/>
              <a:buChar char="»"/>
              <a:tabLst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468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r>
              <a:rPr b="0" lang="en-US" sz="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98760" y="3389400"/>
            <a:ext cx="231768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p>
            <a:pPr indent="0"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241600" y="3389400"/>
            <a:ext cx="1708200" cy="195120"/>
          </a:xfrm>
          <a:prstGeom prst="rect">
            <a:avLst/>
          </a:prstGeom>
          <a:noFill/>
          <a:ln w="0">
            <a:noFill/>
          </a:ln>
        </p:spPr>
        <p:txBody>
          <a:bodyPr lIns="64080" rIns="64080" tIns="32040" bIns="3204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  <a:defRPr b="0" lang="en-US" sz="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fld id="{3D1C66FB-8A2B-42C7-8274-689E752B44C5}" type="slidenum">
              <a:rPr b="0" lang="en-US" sz="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5"/>
          <p:cNvSpPr/>
          <p:nvPr/>
        </p:nvSpPr>
        <p:spPr>
          <a:xfrm rot="10800000">
            <a:off x="-76320" y="914040"/>
            <a:ext cx="492120" cy="152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 vert="eaVer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Percentage occurrenc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4"/>
          <p:cNvSpPr/>
          <p:nvPr/>
        </p:nvSpPr>
        <p:spPr>
          <a:xfrm>
            <a:off x="1392120" y="3378240"/>
            <a:ext cx="4724640" cy="25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78480" rIns="78480" tIns="39240" bIns="39240" anchor="t">
            <a:spAutoFit/>
          </a:bodyPr>
          <a:p>
            <a:pPr algn="ctr"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Stability of secondary structures in Drosophila,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T=24</a:t>
            </a:r>
            <a:r>
              <a:rPr b="0" lang="en-US" sz="1100" spc="-1" strike="noStrike" baseline="50000">
                <a:solidFill>
                  <a:srgbClr val="000000"/>
                </a:solidFill>
                <a:latin typeface="Arial"/>
                <a:ea typeface="宋体"/>
              </a:rPr>
              <a:t>◦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C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 (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−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kcals/mol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8"/>
          <p:cNvSpPr/>
          <p:nvPr/>
        </p:nvSpPr>
        <p:spPr>
          <a:xfrm>
            <a:off x="201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9"/>
          <p:cNvSpPr/>
          <p:nvPr/>
        </p:nvSpPr>
        <p:spPr>
          <a:xfrm>
            <a:off x="3630600" y="-19080"/>
            <a:ext cx="25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8"/>
          <p:cNvSpPr/>
          <p:nvPr/>
        </p:nvSpPr>
        <p:spPr>
          <a:xfrm>
            <a:off x="198000" y="167652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9"/>
          <p:cNvSpPr/>
          <p:nvPr/>
        </p:nvSpPr>
        <p:spPr>
          <a:xfrm>
            <a:off x="3627000" y="1676520"/>
            <a:ext cx="25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78480" rIns="78480" tIns="39240" bIns="39240" anchor="t">
            <a:spAutoFit/>
          </a:bodyPr>
          <a:p>
            <a:pPr>
              <a:tabLst>
                <a:tab algn="l" pos="0"/>
                <a:tab algn="l" pos="895320"/>
                <a:tab algn="l" pos="1790640"/>
                <a:tab algn="l" pos="2685960"/>
                <a:tab algn="l" pos="3581280"/>
                <a:tab algn="l" pos="4476600"/>
                <a:tab algn="l" pos="5372280"/>
                <a:tab algn="l" pos="6267600"/>
                <a:tab algn="l" pos="7162920"/>
                <a:tab algn="l" pos="8058240"/>
                <a:tab algn="l" pos="8953560"/>
                <a:tab algn="l" pos="9848880"/>
                <a:tab algn="l" pos="107442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2"/>
          <p:cNvSpPr/>
          <p:nvPr/>
        </p:nvSpPr>
        <p:spPr>
          <a:xfrm>
            <a:off x="304812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43"/>
          <p:cNvSpPr/>
          <p:nvPr/>
        </p:nvSpPr>
        <p:spPr>
          <a:xfrm>
            <a:off x="308448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4"/>
          <p:cNvSpPr/>
          <p:nvPr/>
        </p:nvSpPr>
        <p:spPr>
          <a:xfrm>
            <a:off x="308448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2"/>
          <p:cNvSpPr/>
          <p:nvPr/>
        </p:nvSpPr>
        <p:spPr>
          <a:xfrm>
            <a:off x="304812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s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3"/>
          <p:cNvSpPr/>
          <p:nvPr/>
        </p:nvSpPr>
        <p:spPr>
          <a:xfrm>
            <a:off x="308448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4"/>
          <p:cNvSpPr/>
          <p:nvPr/>
        </p:nvSpPr>
        <p:spPr>
          <a:xfrm>
            <a:off x="308448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42"/>
          <p:cNvSpPr/>
          <p:nvPr/>
        </p:nvSpPr>
        <p:spPr>
          <a:xfrm>
            <a:off x="6553080" y="30492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43"/>
          <p:cNvSpPr/>
          <p:nvPr/>
        </p:nvSpPr>
        <p:spPr>
          <a:xfrm>
            <a:off x="6589800" y="36972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4"/>
          <p:cNvSpPr/>
          <p:nvPr/>
        </p:nvSpPr>
        <p:spPr>
          <a:xfrm>
            <a:off x="6589800" y="52704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42"/>
          <p:cNvSpPr/>
          <p:nvPr/>
        </p:nvSpPr>
        <p:spPr>
          <a:xfrm>
            <a:off x="6553080" y="2057400"/>
            <a:ext cx="519120" cy="414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91440" bIns="91440" anchor="t">
            <a:spAutoFit/>
          </a:bodyPr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50000"/>
              </a:lnSpc>
              <a:spcBef>
                <a:spcPts val="624"/>
              </a:spcBef>
              <a:tabLst>
                <a:tab algn="l" pos="0"/>
                <a:tab algn="l" pos="784080"/>
                <a:tab algn="l" pos="1568520"/>
                <a:tab algn="l" pos="2352600"/>
                <a:tab algn="l" pos="3137040"/>
                <a:tab algn="l" pos="3921120"/>
                <a:tab algn="l" pos="4705200"/>
                <a:tab algn="l" pos="5489640"/>
                <a:tab algn="l" pos="6273720"/>
                <a:tab algn="l" pos="7058160"/>
                <a:tab algn="l" pos="7842240"/>
                <a:tab algn="l" pos="8626320"/>
                <a:tab algn="l" pos="9410760"/>
                <a:tab algn="l" pos="101948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3"/>
          <p:cNvSpPr/>
          <p:nvPr/>
        </p:nvSpPr>
        <p:spPr>
          <a:xfrm>
            <a:off x="6589800" y="2122560"/>
            <a:ext cx="74520" cy="730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4"/>
          <p:cNvSpPr/>
          <p:nvPr/>
        </p:nvSpPr>
        <p:spPr>
          <a:xfrm>
            <a:off x="6589800" y="2279520"/>
            <a:ext cx="74520" cy="73080"/>
          </a:xfrm>
          <a:prstGeom prst="rect">
            <a:avLst/>
          </a:prstGeom>
          <a:solidFill>
            <a:srgbClr val="a6a6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pPr>
              <a:tabLst>
                <a:tab algn="l" pos="0"/>
                <a:tab algn="l" pos="641520"/>
                <a:tab algn="l" pos="1282680"/>
                <a:tab algn="l" pos="1924200"/>
                <a:tab algn="l" pos="2565360"/>
                <a:tab algn="l" pos="3206880"/>
                <a:tab algn="l" pos="3848040"/>
                <a:tab algn="l" pos="4489560"/>
                <a:tab algn="l" pos="5130720"/>
                <a:tab algn="l" pos="5772240"/>
                <a:tab algn="l" pos="6413400"/>
                <a:tab algn="l" pos="7054920"/>
                <a:tab algn="l" pos="7696080"/>
                <a:tab algn="l" pos="8337600"/>
                <a:tab algn="l" pos="8978760"/>
                <a:tab algn="l" pos="9620280"/>
                <a:tab algn="l" pos="10261440"/>
                <a:tab algn="l" pos="109029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2" descr=""/>
          <p:cNvPicPr/>
          <p:nvPr/>
        </p:nvPicPr>
        <p:blipFill>
          <a:blip r:embed="rId1"/>
          <a:srcRect l="0" t="34400" r="7925" b="23816"/>
          <a:stretch/>
        </p:blipFill>
        <p:spPr>
          <a:xfrm>
            <a:off x="244440" y="1844640"/>
            <a:ext cx="3505320" cy="15890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3" descr=""/>
          <p:cNvPicPr/>
          <p:nvPr/>
        </p:nvPicPr>
        <p:blipFill>
          <a:blip r:embed="rId2"/>
          <a:srcRect l="0" t="34400" r="7925" b="23816"/>
          <a:stretch/>
        </p:blipFill>
        <p:spPr>
          <a:xfrm>
            <a:off x="3757680" y="1844640"/>
            <a:ext cx="3504960" cy="158904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4" descr=""/>
          <p:cNvPicPr/>
          <p:nvPr/>
        </p:nvPicPr>
        <p:blipFill>
          <a:blip r:embed="rId3"/>
          <a:srcRect l="0" t="34400" r="7925" b="23816"/>
          <a:stretch/>
        </p:blipFill>
        <p:spPr>
          <a:xfrm>
            <a:off x="244440" y="130320"/>
            <a:ext cx="3505320" cy="158904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5" descr=""/>
          <p:cNvPicPr/>
          <p:nvPr/>
        </p:nvPicPr>
        <p:blipFill>
          <a:blip r:embed="rId4"/>
          <a:srcRect l="0" t="34400" r="7925" b="23816"/>
          <a:stretch/>
        </p:blipFill>
        <p:spPr>
          <a:xfrm>
            <a:off x="3757680" y="130320"/>
            <a:ext cx="3504960" cy="1589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liangchen</dc:creator>
  <dc:description/>
  <dc:language>en-US</dc:language>
  <cp:lastModifiedBy>USC College of Letters, Arts &amp; Sciences</cp:lastModifiedBy>
  <dcterms:modified xsi:type="dcterms:W3CDTF">2011-01-26T05:06:49Z</dcterms:modified>
  <cp:revision>33</cp:revision>
  <dc:subject/>
  <dc:title>Slide 1</dc:title>
</cp:coreProperties>
</file>